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96" y="36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A063B5-B3DC-42DE-B368-465B31A41E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85D1B7-BD3A-4B01-939A-A8E913871D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887BEF-1974-4953-B63C-5688DA545F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2EB1-0664-4613-BA18-7EE9A5750DEA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3BE474-F99F-450C-BD6B-E422725CBF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B7BE8A-5886-4FBF-9DAA-52D4A3B53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52F-7A0D-4CD6-98D6-31F7A32C9E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881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0E80A6-265C-4051-9952-25224AFC49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DE4CD6-D341-465B-9A7E-FF528C5F5A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38F9D0-6ED9-4118-BD6A-C3D9F55E7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2EB1-0664-4613-BA18-7EE9A5750DEA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188767-0C57-49AB-96F2-C044A1A24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7936B8-B4A5-4C03-8FF2-3304A2677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52F-7A0D-4CD6-98D6-31F7A32C9E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434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A575193-2E4E-4820-8160-F77DB672E8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BF8C263-C84E-4D06-9DD2-5456A80C4E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5DB9B4-1C86-48DB-BCEF-A44B672E4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2EB1-0664-4613-BA18-7EE9A5750DEA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FF1B41-9433-4611-A49F-3B4CBB75D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D29B79-60EC-4D3C-A1F6-715C6CB73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52F-7A0D-4CD6-98D6-31F7A32C9E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241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0E4772-5A1C-446E-92DC-3CB3A82732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6D4E87-2A91-468F-B8B0-D2DA53DDCD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536ABF-0171-4F36-A5DD-4797F450DE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2EB1-0664-4613-BA18-7EE9A5750DEA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6EBC13-6EE8-4279-822E-F83E44058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3812BD-781E-4EB9-BD5A-5FCC01D8E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52F-7A0D-4CD6-98D6-31F7A32C9E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699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CB7FE4-E681-4B00-9500-DDD1D0873A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99C9E7-F197-4310-A4A1-557A8001F6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D2CD10-708F-4834-870E-E3C58F522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2EB1-0664-4613-BA18-7EE9A5750DEA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A5D60F-28AE-4BC9-8EBE-2E12FD8EF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07F38B-D236-4514-9982-1B3FFB5890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52F-7A0D-4CD6-98D6-31F7A32C9E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374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A609ED-C582-4CAB-894E-087F78A09F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CE93B5-FBDD-4297-B2C5-54AA5A1B1E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15670A-68F9-493E-8616-5BC6A4C1DC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4763DB-6A40-41BD-81CE-AD1946D8F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2EB1-0664-4613-BA18-7EE9A5750DEA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E91D10-43A2-4FF3-8ED3-CC2CA93B6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E67E6A-C5E5-4034-B9AB-92EF3291A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52F-7A0D-4CD6-98D6-31F7A32C9E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727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8ECC48-454F-4A04-94C5-A4582C821B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3B346C-353D-4F87-B01A-42ADFED0CD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51BBDB3-92C8-4DF5-86B3-24E8BDA44A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9FFAF54-9DDB-4C15-ACAE-8B5C5B6439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34465CA-0210-4B69-91F2-F6F8FA2D1D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948BC6D-D187-4843-908C-33376B29E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2EB1-0664-4613-BA18-7EE9A5750DEA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5EA6DA-0F4B-4DD4-B7A8-A0A736299F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AC65229-AC87-4913-83A0-67083A0E4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52F-7A0D-4CD6-98D6-31F7A32C9E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4333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46DE82-9542-4389-83C0-890883305D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E713274-E006-42FD-8909-83ACB81EA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2EB1-0664-4613-BA18-7EE9A5750DEA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2F1599F-4938-4DA1-ADF1-EE56E6380A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7CD971D-DB14-4716-8BDD-0784B883E3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52F-7A0D-4CD6-98D6-31F7A32C9E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979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BFE6BF0-ED09-410C-A0AA-782544033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2EB1-0664-4613-BA18-7EE9A5750DEA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CEE89F-9E96-455E-8ABC-08B1BDBBF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8B5B711-81F2-4E44-A7E0-504BFA0014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52F-7A0D-4CD6-98D6-31F7A32C9E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484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A1DC30-1042-4C94-9E83-D727781471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4F7DAA-172A-490C-9161-F9558D1B6D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60721E-2F6F-4284-80D6-66EDD4371E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A28E02-4B1F-493F-AE0A-69F2D5FAFF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2EB1-0664-4613-BA18-7EE9A5750DEA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FAFAF8-DD6F-46AC-8328-B236052046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3F90F7-8EF1-4EB4-904D-DC3B8F3CB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52F-7A0D-4CD6-98D6-31F7A32C9E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345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8FC6F7-3F08-465B-9286-BBB5A83201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497541C-3C6A-4CE4-AD43-FF080D2ED7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D4011DF-DBDE-4740-BE72-1E813F0E14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F3E572-6FDE-4388-AA25-52D5166217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2EB1-0664-4613-BA18-7EE9A5750DEA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9CABB7-1CF2-464C-85F3-1265B2746D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A6DD6A-16B1-43A2-924E-F8FE97E786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52F-7A0D-4CD6-98D6-31F7A32C9E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295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05C2AB-213E-4DBE-B3A1-F91A6FE2DA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6ED309-5954-4C5A-9015-D845D24734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E54263-E56C-4FCD-924E-B1541D940C6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0C2EB1-0664-4613-BA18-7EE9A5750DEA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1A4A0A-1252-45A8-B3CF-291C683E5D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72179A-C59E-4623-AD17-4DA8463F50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69D52F-7A0D-4CD6-98D6-31F7A32C9E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0490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gif"/><Relationship Id="rId5" Type="http://schemas.openxmlformats.org/officeDocument/2006/relationships/image" Target="../media/image4.gif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AB4AC38-ADD5-4989-9887-7D17BE2D3A32}"/>
              </a:ext>
            </a:extLst>
          </p:cNvPr>
          <p:cNvSpPr txBox="1"/>
          <p:nvPr/>
        </p:nvSpPr>
        <p:spPr>
          <a:xfrm>
            <a:off x="3300089" y="267558"/>
            <a:ext cx="18353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wo-step metho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AC615BD-349C-42DD-A314-C0E956B79746}"/>
              </a:ext>
            </a:extLst>
          </p:cNvPr>
          <p:cNvSpPr txBox="1"/>
          <p:nvPr/>
        </p:nvSpPr>
        <p:spPr>
          <a:xfrm>
            <a:off x="6066950" y="270588"/>
            <a:ext cx="726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STLS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EE444808-4010-4718-9F0D-1C7CCD32DD4A}"/>
              </a:ext>
            </a:extLst>
          </p:cNvPr>
          <p:cNvGrpSpPr/>
          <p:nvPr/>
        </p:nvGrpSpPr>
        <p:grpSpPr>
          <a:xfrm>
            <a:off x="7651760" y="2954694"/>
            <a:ext cx="731520" cy="2834640"/>
            <a:chOff x="8480357" y="4243168"/>
            <a:chExt cx="844857" cy="2646306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4679B23-3DC4-4E52-8E03-1DBBF97F701E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31" r="8338" b="1027"/>
            <a:stretch/>
          </p:blipFill>
          <p:spPr>
            <a:xfrm flipH="1">
              <a:off x="8558416" y="4392112"/>
              <a:ext cx="214983" cy="2169099"/>
            </a:xfrm>
            <a:prstGeom prst="rect">
              <a:avLst/>
            </a:prstGeom>
            <a:scene3d>
              <a:camera prst="orthographicFront">
                <a:rot lat="0" lon="0" rev="0"/>
              </a:camera>
              <a:lightRig rig="threePt" dir="t"/>
            </a:scene3d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4EC3749-B9C2-46C9-B346-44D84A30131F}"/>
                </a:ext>
              </a:extLst>
            </p:cNvPr>
            <p:cNvSpPr txBox="1"/>
            <p:nvPr/>
          </p:nvSpPr>
          <p:spPr>
            <a:xfrm>
              <a:off x="8722038" y="5337610"/>
              <a:ext cx="337492" cy="2852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3ADA21C-ABE9-4BA8-9D93-2B533CF82602}"/>
                </a:ext>
              </a:extLst>
            </p:cNvPr>
            <p:cNvSpPr txBox="1"/>
            <p:nvPr/>
          </p:nvSpPr>
          <p:spPr>
            <a:xfrm>
              <a:off x="8739620" y="6339216"/>
              <a:ext cx="585594" cy="2585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0.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1117247-9814-4A4E-BA54-4A565BAD12CD}"/>
                </a:ext>
              </a:extLst>
            </p:cNvPr>
            <p:cNvSpPr txBox="1"/>
            <p:nvPr/>
          </p:nvSpPr>
          <p:spPr>
            <a:xfrm>
              <a:off x="8753689" y="4243168"/>
              <a:ext cx="494826" cy="2585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90050DD-E757-41A6-8915-DD17B047530D}"/>
                </a:ext>
              </a:extLst>
            </p:cNvPr>
            <p:cNvSpPr txBox="1"/>
            <p:nvPr/>
          </p:nvSpPr>
          <p:spPr>
            <a:xfrm>
              <a:off x="8480357" y="6540878"/>
              <a:ext cx="578326" cy="3485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16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cc</a:t>
              </a:r>
              <a:endParaRPr 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2" name="Picture 11">
            <a:extLst>
              <a:ext uri="{FF2B5EF4-FFF2-40B4-BE49-F238E27FC236}">
                <a16:creationId xmlns:a16="http://schemas.microsoft.com/office/drawing/2014/main" id="{84F54839-B78A-4D3B-91A6-694B014B97F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0" t="5514" r="8024" b="5597"/>
          <a:stretch>
            <a:fillRect/>
          </a:stretch>
        </p:blipFill>
        <p:spPr>
          <a:xfrm>
            <a:off x="5287287" y="640778"/>
            <a:ext cx="2286000" cy="2194560"/>
          </a:xfrm>
          <a:custGeom>
            <a:avLst/>
            <a:gdLst>
              <a:gd name="connsiteX0" fmla="*/ 0 w 2286000"/>
              <a:gd name="connsiteY0" fmla="*/ 0 h 2194560"/>
              <a:gd name="connsiteX1" fmla="*/ 2286000 w 2286000"/>
              <a:gd name="connsiteY1" fmla="*/ 0 h 2194560"/>
              <a:gd name="connsiteX2" fmla="*/ 2286000 w 2286000"/>
              <a:gd name="connsiteY2" fmla="*/ 2194560 h 2194560"/>
              <a:gd name="connsiteX3" fmla="*/ 0 w 2286000"/>
              <a:gd name="connsiteY3" fmla="*/ 2194560 h 21945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286000" h="2194560">
                <a:moveTo>
                  <a:pt x="0" y="0"/>
                </a:moveTo>
                <a:lnTo>
                  <a:pt x="2286000" y="0"/>
                </a:lnTo>
                <a:lnTo>
                  <a:pt x="2286000" y="2194560"/>
                </a:lnTo>
                <a:lnTo>
                  <a:pt x="0" y="2194560"/>
                </a:lnTo>
                <a:close/>
              </a:path>
            </a:pathLst>
          </a:cu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88EC860-CFB9-4FA2-BAF1-1F22166C693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43" t="5862" r="9351" b="5862"/>
          <a:stretch>
            <a:fillRect/>
          </a:stretch>
        </p:blipFill>
        <p:spPr>
          <a:xfrm>
            <a:off x="5287287" y="3274734"/>
            <a:ext cx="2286000" cy="2194560"/>
          </a:xfrm>
          <a:custGeom>
            <a:avLst/>
            <a:gdLst>
              <a:gd name="connsiteX0" fmla="*/ 0 w 2286000"/>
              <a:gd name="connsiteY0" fmla="*/ 0 h 2194560"/>
              <a:gd name="connsiteX1" fmla="*/ 2286000 w 2286000"/>
              <a:gd name="connsiteY1" fmla="*/ 0 h 2194560"/>
              <a:gd name="connsiteX2" fmla="*/ 2286000 w 2286000"/>
              <a:gd name="connsiteY2" fmla="*/ 2194560 h 2194560"/>
              <a:gd name="connsiteX3" fmla="*/ 0 w 2286000"/>
              <a:gd name="connsiteY3" fmla="*/ 2194560 h 21945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286000" h="2194560">
                <a:moveTo>
                  <a:pt x="0" y="0"/>
                </a:moveTo>
                <a:lnTo>
                  <a:pt x="2286000" y="0"/>
                </a:lnTo>
                <a:lnTo>
                  <a:pt x="2286000" y="2194560"/>
                </a:lnTo>
                <a:lnTo>
                  <a:pt x="0" y="2194560"/>
                </a:lnTo>
                <a:close/>
              </a:path>
            </a:pathLst>
          </a:cu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A09CC67-CE29-4D42-9342-2F51DD55575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16" t="5862" r="9978" b="5862"/>
          <a:stretch>
            <a:fillRect/>
          </a:stretch>
        </p:blipFill>
        <p:spPr>
          <a:xfrm>
            <a:off x="2922814" y="3280177"/>
            <a:ext cx="2286000" cy="2194560"/>
          </a:xfrm>
          <a:custGeom>
            <a:avLst/>
            <a:gdLst>
              <a:gd name="connsiteX0" fmla="*/ 0 w 2286000"/>
              <a:gd name="connsiteY0" fmla="*/ 0 h 2194560"/>
              <a:gd name="connsiteX1" fmla="*/ 2286000 w 2286000"/>
              <a:gd name="connsiteY1" fmla="*/ 0 h 2194560"/>
              <a:gd name="connsiteX2" fmla="*/ 2286000 w 2286000"/>
              <a:gd name="connsiteY2" fmla="*/ 2194560 h 2194560"/>
              <a:gd name="connsiteX3" fmla="*/ 0 w 2286000"/>
              <a:gd name="connsiteY3" fmla="*/ 2194560 h 21945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286000" h="2194560">
                <a:moveTo>
                  <a:pt x="0" y="0"/>
                </a:moveTo>
                <a:lnTo>
                  <a:pt x="2286000" y="0"/>
                </a:lnTo>
                <a:lnTo>
                  <a:pt x="2286000" y="2194560"/>
                </a:lnTo>
                <a:lnTo>
                  <a:pt x="0" y="2194560"/>
                </a:lnTo>
                <a:close/>
              </a:path>
            </a:pathLst>
          </a:cu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34160F0-5407-4146-B482-FA558A38A35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61" t="5514" r="7903" b="5597"/>
          <a:stretch>
            <a:fillRect/>
          </a:stretch>
        </p:blipFill>
        <p:spPr>
          <a:xfrm>
            <a:off x="2933700" y="636890"/>
            <a:ext cx="2286000" cy="2194560"/>
          </a:xfrm>
          <a:custGeom>
            <a:avLst/>
            <a:gdLst>
              <a:gd name="connsiteX0" fmla="*/ 0 w 2286000"/>
              <a:gd name="connsiteY0" fmla="*/ 0 h 2194560"/>
              <a:gd name="connsiteX1" fmla="*/ 2286000 w 2286000"/>
              <a:gd name="connsiteY1" fmla="*/ 0 h 2194560"/>
              <a:gd name="connsiteX2" fmla="*/ 2286000 w 2286000"/>
              <a:gd name="connsiteY2" fmla="*/ 2194560 h 2194560"/>
              <a:gd name="connsiteX3" fmla="*/ 0 w 2286000"/>
              <a:gd name="connsiteY3" fmla="*/ 2194560 h 21945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286000" h="2194560">
                <a:moveTo>
                  <a:pt x="0" y="0"/>
                </a:moveTo>
                <a:lnTo>
                  <a:pt x="2286000" y="0"/>
                </a:lnTo>
                <a:lnTo>
                  <a:pt x="2286000" y="2194560"/>
                </a:lnTo>
                <a:lnTo>
                  <a:pt x="0" y="2194560"/>
                </a:lnTo>
                <a:close/>
              </a:path>
            </a:pathLst>
          </a:cu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8EA270A-BF74-40E1-B37C-C998396D4613}"/>
              </a:ext>
            </a:extLst>
          </p:cNvPr>
          <p:cNvSpPr txBox="1"/>
          <p:nvPr/>
        </p:nvSpPr>
        <p:spPr>
          <a:xfrm>
            <a:off x="2581129" y="5828791"/>
            <a:ext cx="622365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dirty="0"/>
              <a:t>Example Lagrangian displacement trajectories (A) and circumferential strain (B) movies comparing the two-step method and the RSTLS method for a healthy volunteer.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0CA5A08-0583-4145-BBAD-76246460AE0C}"/>
              </a:ext>
            </a:extLst>
          </p:cNvPr>
          <p:cNvSpPr txBox="1"/>
          <p:nvPr/>
        </p:nvSpPr>
        <p:spPr>
          <a:xfrm>
            <a:off x="2353824" y="371553"/>
            <a:ext cx="4109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67DE951-4AFB-4647-9396-AAF7B1184283}"/>
              </a:ext>
            </a:extLst>
          </p:cNvPr>
          <p:cNvSpPr txBox="1"/>
          <p:nvPr/>
        </p:nvSpPr>
        <p:spPr>
          <a:xfrm>
            <a:off x="2353824" y="3114238"/>
            <a:ext cx="3978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461645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08</TotalTime>
  <Words>39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hadimi, Sona (sq9qd)</dc:creator>
  <cp:lastModifiedBy>Ghadimi, Sona (sq9qd)</cp:lastModifiedBy>
  <cp:revision>6</cp:revision>
  <dcterms:created xsi:type="dcterms:W3CDTF">2022-11-09T18:22:29Z</dcterms:created>
  <dcterms:modified xsi:type="dcterms:W3CDTF">2023-02-20T18:58:40Z</dcterms:modified>
</cp:coreProperties>
</file>